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6"/>
  </p:notesMasterIdLst>
  <p:sldIdLst>
    <p:sldId id="277" r:id="rId2"/>
    <p:sldId id="256" r:id="rId3"/>
    <p:sldId id="278" r:id="rId4"/>
    <p:sldId id="279" r:id="rId5"/>
  </p:sldIdLst>
  <p:sldSz cx="7559675" cy="1069181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747775"/>
          </p15:clr>
        </p15:guide>
        <p15:guide id="2" pos="2381">
          <p15:clr>
            <a:srgbClr val="747775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17CAC24-9916-5F0F-3075-C92ADEE8D8F4}" name="Tan, M. (CCB)" initials="MT" userId="S::m.tan@lumc.nl::244730e4-7897-41f4-8b5f-326c0650be7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3186" y="66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17050" y="685800"/>
            <a:ext cx="2424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e49e75d38b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e49e75d38b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57712" y="1547778"/>
            <a:ext cx="7044600" cy="42669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57705" y="5891409"/>
            <a:ext cx="7044600" cy="1647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57705" y="2299346"/>
            <a:ext cx="7044600" cy="4081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57705" y="6552657"/>
            <a:ext cx="7044600" cy="2703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57705" y="4471058"/>
            <a:ext cx="7044600" cy="1749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33069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995291" y="2395696"/>
            <a:ext cx="33069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57705" y="1154948"/>
            <a:ext cx="2321700" cy="1570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57705" y="2888617"/>
            <a:ext cx="2321700" cy="6609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05325" y="935745"/>
            <a:ext cx="5264700" cy="8503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0000" y="-260"/>
            <a:ext cx="3780000" cy="10692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19508" y="2563450"/>
            <a:ext cx="3344400" cy="3081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19508" y="5826865"/>
            <a:ext cx="3344400" cy="2567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083839" y="1505164"/>
            <a:ext cx="3172200" cy="7681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57705" y="8794266"/>
            <a:ext cx="4959600" cy="1257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zh-C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3" Type="http://schemas.openxmlformats.org/officeDocument/2006/relationships/image" Target="../media/image1.png"/><Relationship Id="rId7" Type="http://schemas.openxmlformats.org/officeDocument/2006/relationships/image" Target="../media/image3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47A010-5595-CFB4-0660-24DDEAF291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7537" y="2844800"/>
            <a:ext cx="7044600" cy="4433330"/>
          </a:xfrm>
        </p:spPr>
        <p:txBody>
          <a:bodyPr>
            <a:normAutofit/>
          </a:bodyPr>
          <a:lstStyle/>
          <a:p>
            <a:pPr algn="l">
              <a:lnSpc>
                <a:spcPct val="150000"/>
              </a:lnSpc>
            </a:pP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hengnan Sun1,3, </a:t>
            </a:r>
            <a:r>
              <a:rPr lang="en-U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nhong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un2,3, Minkang Tan1, Maarten Kip1, </a:t>
            </a:r>
            <a:r>
              <a:rPr lang="en-U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Xiaobao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Yang2*, Baoxu Pang1*</a:t>
            </a:r>
            <a:b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Department of Cell and Chemical Biology, Leiden University Medical Center, Leiden, The Netherlands</a:t>
            </a:r>
            <a:b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Gluetacs Therapeutics (Shanghai) Co, Ltd, Pudong District, Shanghai, China</a:t>
            </a:r>
            <a:b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These authors contributed equally</a:t>
            </a:r>
            <a:b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*Correspondence: b.pang@lumc.nl (B.P.), yang.xiaobao@gluetacs.com (X.Y.)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96989FC8-E197-B403-F0C4-7A37CDF8E3D0}"/>
              </a:ext>
            </a:extLst>
          </p:cNvPr>
          <p:cNvSpPr txBox="1">
            <a:spLocks/>
          </p:cNvSpPr>
          <p:nvPr/>
        </p:nvSpPr>
        <p:spPr>
          <a:xfrm>
            <a:off x="257537" y="1465942"/>
            <a:ext cx="7044600" cy="13441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>
              <a:lnSpc>
                <a:spcPct val="150000"/>
              </a:lnSpc>
            </a:pPr>
            <a:r>
              <a:rPr lang="en-US" sz="1600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information related to</a:t>
            </a:r>
          </a:p>
          <a:p>
            <a:pPr>
              <a:lnSpc>
                <a:spcPct val="150000"/>
              </a:lnSpc>
            </a:pPr>
            <a:endParaRPr lang="en-US" sz="1600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</a:rPr>
              <a:t>PROTAC molecule-mediated SpCas9 protein degradation for precise genome editing</a:t>
            </a:r>
            <a:endParaRPr lang="nl-NL" sz="1600" dirty="0"/>
          </a:p>
        </p:txBody>
      </p:sp>
    </p:spTree>
    <p:extLst>
      <p:ext uri="{BB962C8B-B14F-4D97-AF65-F5344CB8AC3E}">
        <p14:creationId xmlns:p14="http://schemas.microsoft.com/office/powerpoint/2010/main" val="451344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0576AE4-45B2-C4F4-A104-8090A199B5B7}"/>
              </a:ext>
            </a:extLst>
          </p:cNvPr>
          <p:cNvGrpSpPr/>
          <p:nvPr/>
        </p:nvGrpSpPr>
        <p:grpSpPr>
          <a:xfrm>
            <a:off x="-2775" y="2922985"/>
            <a:ext cx="7890645" cy="1682876"/>
            <a:chOff x="2259870" y="1360349"/>
            <a:chExt cx="7890645" cy="168287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9A945C2-5476-716A-C67D-12E6F14229D3}"/>
                </a:ext>
              </a:extLst>
            </p:cNvPr>
            <p:cNvSpPr txBox="1"/>
            <p:nvPr/>
          </p:nvSpPr>
          <p:spPr>
            <a:xfrm>
              <a:off x="2791544" y="2003670"/>
              <a:ext cx="38193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Ctr       0        1         2         3        5          7     day (s)</a:t>
              </a:r>
              <a:endParaRPr lang="nl-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F678ED3-45DD-8155-4FF8-0C8F4F3B95D9}"/>
                </a:ext>
              </a:extLst>
            </p:cNvPr>
            <p:cNvSpPr txBox="1"/>
            <p:nvPr/>
          </p:nvSpPr>
          <p:spPr>
            <a:xfrm>
              <a:off x="2259870" y="1360349"/>
              <a:ext cx="1888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B649431-AE3B-0C52-6D7B-EFE871070797}"/>
                </a:ext>
              </a:extLst>
            </p:cNvPr>
            <p:cNvSpPr txBox="1"/>
            <p:nvPr/>
          </p:nvSpPr>
          <p:spPr>
            <a:xfrm>
              <a:off x="6069949" y="1360349"/>
              <a:ext cx="4154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nl-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 descr="A picture containing antenna&#10;&#10;Description automatically generated">
              <a:extLst>
                <a:ext uri="{FF2B5EF4-FFF2-40B4-BE49-F238E27FC236}">
                  <a16:creationId xmlns:a16="http://schemas.microsoft.com/office/drawing/2014/main" id="{7153B1F8-CE17-1DE6-A007-E73960EB3B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82" t="61949" r="26657" b="29245"/>
            <a:stretch/>
          </p:blipFill>
          <p:spPr>
            <a:xfrm>
              <a:off x="2958189" y="2661340"/>
              <a:ext cx="2673705" cy="381885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70985A4-B3A6-CF25-A0D9-C03B735E76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67" t="66321" r="24116" b="26462"/>
            <a:stretch/>
          </p:blipFill>
          <p:spPr>
            <a:xfrm>
              <a:off x="2937988" y="2284297"/>
              <a:ext cx="2653738" cy="305290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52D04658-B4BC-0EA3-2606-B98C4CD85C12}"/>
                </a:ext>
              </a:extLst>
            </p:cNvPr>
            <p:cNvSpPr/>
            <p:nvPr/>
          </p:nvSpPr>
          <p:spPr>
            <a:xfrm>
              <a:off x="2925836" y="2266541"/>
              <a:ext cx="2665890" cy="3257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F203A81C-11AB-7637-5978-B08ACE3DF224}"/>
                </a:ext>
              </a:extLst>
            </p:cNvPr>
            <p:cNvSpPr/>
            <p:nvPr/>
          </p:nvSpPr>
          <p:spPr>
            <a:xfrm>
              <a:off x="2931912" y="2683155"/>
              <a:ext cx="2665890" cy="3257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8B249CC-D583-622D-B7B7-D917E8FAA6D9}"/>
                </a:ext>
              </a:extLst>
            </p:cNvPr>
            <p:cNvSpPr txBox="1"/>
            <p:nvPr/>
          </p:nvSpPr>
          <p:spPr>
            <a:xfrm>
              <a:off x="2299719" y="2324532"/>
              <a:ext cx="1083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s9-HA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F6377C7A-0222-E302-70E6-E909348D5D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66877" y="1963814"/>
              <a:ext cx="2224849" cy="3383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9763E75A-BB7B-3E5B-7B14-635845616B2B}"/>
                </a:ext>
              </a:extLst>
            </p:cNvPr>
            <p:cNvSpPr/>
            <p:nvPr/>
          </p:nvSpPr>
          <p:spPr>
            <a:xfrm>
              <a:off x="3227024" y="1674835"/>
              <a:ext cx="27350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nl-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ransfected with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RISPR plasmid (24 hrs)</a:t>
              </a:r>
              <a:endParaRPr lang="nl-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3E50FA9-D480-58A8-6CF1-34BE3765CFA1}"/>
                </a:ext>
              </a:extLst>
            </p:cNvPr>
            <p:cNvSpPr txBox="1"/>
            <p:nvPr/>
          </p:nvSpPr>
          <p:spPr>
            <a:xfrm>
              <a:off x="7006018" y="1974991"/>
              <a:ext cx="31444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Ctr    0      1      2       3        5        7   day (s)</a:t>
              </a:r>
              <a:endParaRPr lang="nl-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69679EE-4024-48D1-2F6C-ED26E3CC8951}"/>
                </a:ext>
              </a:extLst>
            </p:cNvPr>
            <p:cNvSpPr txBox="1"/>
            <p:nvPr/>
          </p:nvSpPr>
          <p:spPr>
            <a:xfrm>
              <a:off x="6162631" y="2307670"/>
              <a:ext cx="12916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Cas9-APEX2                                      </a:t>
              </a:r>
              <a:r>
                <a:rPr lang="nl-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FB5892F5-5D42-D230-8C45-62C2A6EAEFD8}"/>
                </a:ext>
              </a:extLst>
            </p:cNvPr>
            <p:cNvCxnSpPr>
              <a:cxnSpLocks/>
            </p:cNvCxnSpPr>
            <p:nvPr/>
          </p:nvCxnSpPr>
          <p:spPr>
            <a:xfrm>
              <a:off x="7389619" y="1895062"/>
              <a:ext cx="1929915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B225E8D-3196-83CE-187F-BBE1FD5438FB}"/>
                </a:ext>
              </a:extLst>
            </p:cNvPr>
            <p:cNvSpPr/>
            <p:nvPr/>
          </p:nvSpPr>
          <p:spPr>
            <a:xfrm>
              <a:off x="7267547" y="1616583"/>
              <a:ext cx="219964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nl-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reated with doxycycline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24 hrs)</a:t>
              </a:r>
              <a:endParaRPr lang="nl-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A9A6DD49-D9D9-876A-1600-755590761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24" t="40466" r="18175" b="48771"/>
            <a:stretch/>
          </p:blipFill>
          <p:spPr>
            <a:xfrm>
              <a:off x="7097445" y="2190435"/>
              <a:ext cx="2268552" cy="367428"/>
            </a:xfrm>
            <a:prstGeom prst="rect">
              <a:avLst/>
            </a:prstGeom>
          </p:spPr>
        </p:pic>
        <p:pic>
          <p:nvPicPr>
            <p:cNvPr id="19" name="Picture 18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85C018C1-386F-1776-7CB8-FEF13B1528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00" t="48678" r="20475" b="41823"/>
            <a:stretch/>
          </p:blipFill>
          <p:spPr>
            <a:xfrm rot="174056">
              <a:off x="7175305" y="2703076"/>
              <a:ext cx="2137393" cy="324257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B935A2D-370A-BAAE-21B9-B2C24FC861CF}"/>
                </a:ext>
              </a:extLst>
            </p:cNvPr>
            <p:cNvSpPr txBox="1"/>
            <p:nvPr/>
          </p:nvSpPr>
          <p:spPr>
            <a:xfrm>
              <a:off x="2401468" y="2737232"/>
              <a:ext cx="65669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nl-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FE1BAECF-F260-CA8B-081B-E737B455CC45}"/>
                </a:ext>
              </a:extLst>
            </p:cNvPr>
            <p:cNvSpPr/>
            <p:nvPr/>
          </p:nvSpPr>
          <p:spPr>
            <a:xfrm>
              <a:off x="7147835" y="2238575"/>
              <a:ext cx="2277515" cy="3257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DBC5C89-B000-A795-AA59-D099B300EB71}"/>
                </a:ext>
              </a:extLst>
            </p:cNvPr>
            <p:cNvSpPr/>
            <p:nvPr/>
          </p:nvSpPr>
          <p:spPr>
            <a:xfrm>
              <a:off x="7147835" y="2669222"/>
              <a:ext cx="2277515" cy="3257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69AAB88-735F-08F9-EEE7-79B4B99AA320}"/>
                </a:ext>
              </a:extLst>
            </p:cNvPr>
            <p:cNvSpPr txBox="1"/>
            <p:nvPr/>
          </p:nvSpPr>
          <p:spPr>
            <a:xfrm>
              <a:off x="6610852" y="2739565"/>
              <a:ext cx="65669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nl-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24" name="Rectangle 23">
            <a:extLst>
              <a:ext uri="{FF2B5EF4-FFF2-40B4-BE49-F238E27FC236}">
                <a16:creationId xmlns:a16="http://schemas.microsoft.com/office/drawing/2014/main" id="{752C907F-2111-BD6A-9DCE-AB0F4D5C8A28}"/>
              </a:ext>
            </a:extLst>
          </p:cNvPr>
          <p:cNvSpPr/>
          <p:nvPr/>
        </p:nvSpPr>
        <p:spPr>
          <a:xfrm>
            <a:off x="132610" y="5556241"/>
            <a:ext cx="7306253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Half-life of the Cas9 and dCas9 proteins in cells.</a:t>
            </a:r>
          </a:p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293T cells were transiently transfected with plasmids expressing SpCas9 proteins. The half-life of the SpCas9 proteins was monitored at different time points.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in was used as the loading control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93T cells stably expressing the dCas9-APEX2 under the tetracycline-controlled Tet-On inducible gene expression system. The expression of dCas9-APEX2 was induced for one day by doxycycline (dox). Then, the dox was removed, and the transcription of dCas9 stopped. The half-life of the dCas9 proteins was monitored at different time points. The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in was used as the loading control.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D1BEC8C-649C-6C58-4CD4-26996FC876D4}"/>
              </a:ext>
            </a:extLst>
          </p:cNvPr>
          <p:cNvSpPr txBox="1"/>
          <p:nvPr/>
        </p:nvSpPr>
        <p:spPr>
          <a:xfrm>
            <a:off x="24035" y="204470"/>
            <a:ext cx="39442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endParaRPr lang="nl-NL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4065A9-44FF-9EC0-0F2F-815FA51BA940}"/>
              </a:ext>
            </a:extLst>
          </p:cNvPr>
          <p:cNvSpPr txBox="1"/>
          <p:nvPr/>
        </p:nvSpPr>
        <p:spPr>
          <a:xfrm>
            <a:off x="24035" y="3154862"/>
            <a:ext cx="415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161AD41-A09C-90D3-503E-48F7238ACD9B}"/>
              </a:ext>
            </a:extLst>
          </p:cNvPr>
          <p:cNvGrpSpPr/>
          <p:nvPr/>
        </p:nvGrpSpPr>
        <p:grpSpPr>
          <a:xfrm>
            <a:off x="-193355" y="3431861"/>
            <a:ext cx="6711551" cy="3462811"/>
            <a:chOff x="5263187" y="1220271"/>
            <a:chExt cx="6711551" cy="346281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FD78CBF-15B7-07FD-1206-86A80F145473}"/>
                </a:ext>
              </a:extLst>
            </p:cNvPr>
            <p:cNvGrpSpPr/>
            <p:nvPr/>
          </p:nvGrpSpPr>
          <p:grpSpPr>
            <a:xfrm>
              <a:off x="5263187" y="1220271"/>
              <a:ext cx="6711551" cy="3376530"/>
              <a:chOff x="1536232" y="1210708"/>
              <a:chExt cx="6711551" cy="3376530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95349B7-F8B4-7053-60BD-8BA52E81D2A1}"/>
                  </a:ext>
                </a:extLst>
              </p:cNvPr>
              <p:cNvSpPr/>
              <p:nvPr/>
            </p:nvSpPr>
            <p:spPr>
              <a:xfrm>
                <a:off x="1739013" y="1768704"/>
                <a:ext cx="941283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GFP-</a:t>
                </a:r>
                <a:r>
                  <a:rPr lang="en-US" sz="900" b="1" dirty="0" err="1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Ontarg</a:t>
                </a:r>
                <a:endParaRPr lang="nl-NL" sz="700" b="1" dirty="0">
                  <a:solidFill>
                    <a:srgbClr val="FFFFFF"/>
                  </a:solidFill>
                  <a:latin typeface="Verdana" panose="020B0604030504040204" pitchFamily="34" charset="0"/>
                  <a:ea typeface="Verdana" panose="020B0604030504040204" pitchFamily="34" charset="0"/>
                </a:endParaRP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F673345F-177B-2D35-64EA-2BFF13110A71}"/>
                  </a:ext>
                </a:extLst>
              </p:cNvPr>
              <p:cNvSpPr/>
              <p:nvPr/>
            </p:nvSpPr>
            <p:spPr>
              <a:xfrm>
                <a:off x="1536232" y="3907785"/>
                <a:ext cx="110479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      Offtarg-2 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0FDDFA72-5C16-995A-745B-82DB854F1B84}"/>
                  </a:ext>
                </a:extLst>
              </p:cNvPr>
              <p:cNvSpPr/>
              <p:nvPr/>
            </p:nvSpPr>
            <p:spPr>
              <a:xfrm>
                <a:off x="1536232" y="2764510"/>
                <a:ext cx="1024639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     Offtarg-1</a:t>
                </a:r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1210FDCB-D6D5-9360-6786-85F1BF69EA26}"/>
                  </a:ext>
                </a:extLst>
              </p:cNvPr>
              <p:cNvGrpSpPr/>
              <p:nvPr/>
            </p:nvGrpSpPr>
            <p:grpSpPr>
              <a:xfrm>
                <a:off x="2719357" y="1210708"/>
                <a:ext cx="5528426" cy="3376530"/>
                <a:chOff x="2321219" y="1066057"/>
                <a:chExt cx="5528426" cy="3376530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ED3E5208-A369-F29E-11CC-5D679FE0603E}"/>
                    </a:ext>
                  </a:extLst>
                </p:cNvPr>
                <p:cNvSpPr/>
                <p:nvPr/>
              </p:nvSpPr>
              <p:spPr>
                <a:xfrm>
                  <a:off x="2374386" y="1066057"/>
                  <a:ext cx="5469895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Verdana" panose="020B0604030504040204" pitchFamily="34" charset="0"/>
                      <a:ea typeface="Verdana" panose="020B0604030504040204" pitchFamily="34" charset="0"/>
                      <a:cs typeface="Arial" panose="020B0604020202020204" pitchFamily="34" charset="0"/>
                    </a:rPr>
                    <a:t>            24 h                   36 h                 48 h                  60 h                  72 h   </a:t>
                  </a:r>
                  <a:endParaRPr lang="nl-NL" sz="900" b="1" dirty="0">
                    <a:solidFill>
                      <a:srgbClr val="FFFFFF"/>
                    </a:solidFill>
                    <a:latin typeface="Verdana" panose="020B0604030504040204" pitchFamily="34" charset="0"/>
                    <a:ea typeface="Verdana" panose="020B0604030504040204" pitchFamily="34" charset="0"/>
                  </a:endParaRPr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4BF356F7-C673-3307-1FA5-900897911836}"/>
                    </a:ext>
                  </a:extLst>
                </p:cNvPr>
                <p:cNvGrpSpPr/>
                <p:nvPr/>
              </p:nvGrpSpPr>
              <p:grpSpPr>
                <a:xfrm>
                  <a:off x="2321219" y="1209160"/>
                  <a:ext cx="5438843" cy="1085313"/>
                  <a:chOff x="3904769" y="-1085313"/>
                  <a:chExt cx="5438843" cy="1085313"/>
                </a:xfrm>
              </p:grpSpPr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A265287E-9C89-8E21-C2A2-EBB05E29DF2A}"/>
                      </a:ext>
                    </a:extLst>
                  </p:cNvPr>
                  <p:cNvGrpSpPr/>
                  <p:nvPr/>
                </p:nvGrpSpPr>
                <p:grpSpPr>
                  <a:xfrm>
                    <a:off x="3904769" y="-1085313"/>
                    <a:ext cx="5232087" cy="1085313"/>
                    <a:chOff x="3904769" y="-1085313"/>
                    <a:chExt cx="5232087" cy="1085313"/>
                  </a:xfrm>
                </p:grpSpPr>
                <p:pic>
                  <p:nvPicPr>
                    <p:cNvPr id="40" name="Picture 39">
                      <a:extLst>
                        <a:ext uri="{FF2B5EF4-FFF2-40B4-BE49-F238E27FC236}">
                          <a16:creationId xmlns:a16="http://schemas.microsoft.com/office/drawing/2014/main" id="{A1F757C6-1DC5-64A4-9F73-4054974BDF2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73846" r="64402" b="17493"/>
                    <a:stretch/>
                  </p:blipFill>
                  <p:spPr>
                    <a:xfrm>
                      <a:off x="3904769" y="-1085313"/>
                      <a:ext cx="2199253" cy="107439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1" name="Picture 40">
                      <a:extLst>
                        <a:ext uri="{FF2B5EF4-FFF2-40B4-BE49-F238E27FC236}">
                          <a16:creationId xmlns:a16="http://schemas.microsoft.com/office/drawing/2014/main" id="{E186A62E-63AE-261C-A7CA-277B667733A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0538" t="73846" r="-1810" b="17493"/>
                    <a:stretch/>
                  </p:blipFill>
                  <p:spPr>
                    <a:xfrm>
                      <a:off x="5969213" y="-1074393"/>
                      <a:ext cx="3167643" cy="1074393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2F7DC001-F7C9-8478-1F1B-6F5E2AFFF1E0}"/>
                      </a:ext>
                    </a:extLst>
                  </p:cNvPr>
                  <p:cNvSpPr txBox="1"/>
                  <p:nvPr/>
                </p:nvSpPr>
                <p:spPr>
                  <a:xfrm>
                    <a:off x="8098182" y="-348318"/>
                    <a:ext cx="124543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47.1  52.7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CAAC5998-7BD2-7A04-6210-2E39C9B7EC8C}"/>
                      </a:ext>
                    </a:extLst>
                  </p:cNvPr>
                  <p:cNvSpPr txBox="1"/>
                  <p:nvPr/>
                </p:nvSpPr>
                <p:spPr>
                  <a:xfrm>
                    <a:off x="4145179" y="-373061"/>
                    <a:ext cx="138423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0.90  98.9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15C5AE9A-B69B-511B-2134-AF84A01F1DE0}"/>
                      </a:ext>
                    </a:extLst>
                  </p:cNvPr>
                  <p:cNvSpPr txBox="1"/>
                  <p:nvPr/>
                </p:nvSpPr>
                <p:spPr>
                  <a:xfrm>
                    <a:off x="5132027" y="-373061"/>
                    <a:ext cx="126843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14.6  85.2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420CD0EA-DC19-AC59-0C37-D014190A2135}"/>
                      </a:ext>
                    </a:extLst>
                  </p:cNvPr>
                  <p:cNvSpPr txBox="1"/>
                  <p:nvPr/>
                </p:nvSpPr>
                <p:spPr>
                  <a:xfrm>
                    <a:off x="6074658" y="-362547"/>
                    <a:ext cx="139816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25.3  74.5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64BB4F50-84B7-3E45-7BBE-A89FCCEBAD79}"/>
                      </a:ext>
                    </a:extLst>
                  </p:cNvPr>
                  <p:cNvSpPr txBox="1"/>
                  <p:nvPr/>
                </p:nvSpPr>
                <p:spPr>
                  <a:xfrm>
                    <a:off x="7077000" y="-354026"/>
                    <a:ext cx="131158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46.8  53.1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BCE431DA-036D-CF4E-FFEC-C647D546EAAA}"/>
                    </a:ext>
                  </a:extLst>
                </p:cNvPr>
                <p:cNvGrpSpPr/>
                <p:nvPr/>
              </p:nvGrpSpPr>
              <p:grpSpPr>
                <a:xfrm>
                  <a:off x="2477117" y="2266074"/>
                  <a:ext cx="5372528" cy="1005434"/>
                  <a:chOff x="2477117" y="2266074"/>
                  <a:chExt cx="5372528" cy="1005434"/>
                </a:xfrm>
              </p:grpSpPr>
              <p:grpSp>
                <p:nvGrpSpPr>
                  <p:cNvPr id="26" name="Group 25">
                    <a:extLst>
                      <a:ext uri="{FF2B5EF4-FFF2-40B4-BE49-F238E27FC236}">
                        <a16:creationId xmlns:a16="http://schemas.microsoft.com/office/drawing/2014/main" id="{17E2ABF2-CA56-C519-062F-53CDE3D493EF}"/>
                      </a:ext>
                    </a:extLst>
                  </p:cNvPr>
                  <p:cNvGrpSpPr/>
                  <p:nvPr/>
                </p:nvGrpSpPr>
                <p:grpSpPr>
                  <a:xfrm>
                    <a:off x="2477117" y="2266074"/>
                    <a:ext cx="4965429" cy="1005434"/>
                    <a:chOff x="2477117" y="2266074"/>
                    <a:chExt cx="4965429" cy="1005434"/>
                  </a:xfrm>
                </p:grpSpPr>
                <p:pic>
                  <p:nvPicPr>
                    <p:cNvPr id="32" name="Picture 31">
                      <a:extLst>
                        <a:ext uri="{FF2B5EF4-FFF2-40B4-BE49-F238E27FC236}">
                          <a16:creationId xmlns:a16="http://schemas.microsoft.com/office/drawing/2014/main" id="{98319A39-8187-0EE0-1B13-1ECEE56C913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533" t="53303" r="66182" b="38474"/>
                    <a:stretch/>
                  </p:blipFill>
                  <p:spPr>
                    <a:xfrm>
                      <a:off x="2477117" y="2271752"/>
                      <a:ext cx="1967632" cy="98886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3" name="Picture 32">
                      <a:extLst>
                        <a:ext uri="{FF2B5EF4-FFF2-40B4-BE49-F238E27FC236}">
                          <a16:creationId xmlns:a16="http://schemas.microsoft.com/office/drawing/2014/main" id="{1C29134C-40D4-63D8-6EAE-FB064D0C568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9756" t="53303" r="1432" b="38474"/>
                    <a:stretch/>
                  </p:blipFill>
                  <p:spPr>
                    <a:xfrm>
                      <a:off x="4417832" y="2266074"/>
                      <a:ext cx="3024714" cy="1005434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86BB8863-5BE0-3C86-CCD7-F919ED7C789F}"/>
                      </a:ext>
                    </a:extLst>
                  </p:cNvPr>
                  <p:cNvSpPr txBox="1"/>
                  <p:nvPr/>
                </p:nvSpPr>
                <p:spPr>
                  <a:xfrm>
                    <a:off x="6517401" y="2952772"/>
                    <a:ext cx="13322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16.5  83.3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6F383195-99E9-558F-AFF2-CB1F1567EABC}"/>
                      </a:ext>
                    </a:extLst>
                  </p:cNvPr>
                  <p:cNvSpPr txBox="1"/>
                  <p:nvPr/>
                </p:nvSpPr>
                <p:spPr>
                  <a:xfrm>
                    <a:off x="2553867" y="2933983"/>
                    <a:ext cx="1254788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0.75  99.1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21EB8D60-EB97-2E24-3148-380547D38E77}"/>
                      </a:ext>
                    </a:extLst>
                  </p:cNvPr>
                  <p:cNvSpPr txBox="1"/>
                  <p:nvPr/>
                </p:nvSpPr>
                <p:spPr>
                  <a:xfrm>
                    <a:off x="3547741" y="2944159"/>
                    <a:ext cx="125074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5.47  94.4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EC206038-F7FA-63D7-7FD8-576721C14209}"/>
                      </a:ext>
                    </a:extLst>
                  </p:cNvPr>
                  <p:cNvSpPr txBox="1"/>
                  <p:nvPr/>
                </p:nvSpPr>
                <p:spPr>
                  <a:xfrm>
                    <a:off x="4513703" y="2955048"/>
                    <a:ext cx="153453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9.16  90.8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159AC054-4A05-9D2A-AB22-C4AF18F39E40}"/>
                      </a:ext>
                    </a:extLst>
                  </p:cNvPr>
                  <p:cNvSpPr txBox="1"/>
                  <p:nvPr/>
                </p:nvSpPr>
                <p:spPr>
                  <a:xfrm>
                    <a:off x="5521826" y="2955951"/>
                    <a:ext cx="125074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16.6  83.4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28B6B8D5-F2CF-F293-BE60-4A11C2E5754A}"/>
                    </a:ext>
                  </a:extLst>
                </p:cNvPr>
                <p:cNvGrpSpPr/>
                <p:nvPr/>
              </p:nvGrpSpPr>
              <p:grpSpPr>
                <a:xfrm>
                  <a:off x="2452729" y="3363738"/>
                  <a:ext cx="5357102" cy="1078849"/>
                  <a:chOff x="5216696" y="6966863"/>
                  <a:chExt cx="5357102" cy="1078849"/>
                </a:xfrm>
              </p:grpSpPr>
              <p:grpSp>
                <p:nvGrpSpPr>
                  <p:cNvPr id="18" name="Group 17">
                    <a:extLst>
                      <a:ext uri="{FF2B5EF4-FFF2-40B4-BE49-F238E27FC236}">
                        <a16:creationId xmlns:a16="http://schemas.microsoft.com/office/drawing/2014/main" id="{CBEE58D0-7B9C-A0C9-B89A-FEE51663E81A}"/>
                      </a:ext>
                    </a:extLst>
                  </p:cNvPr>
                  <p:cNvGrpSpPr/>
                  <p:nvPr/>
                </p:nvGrpSpPr>
                <p:grpSpPr>
                  <a:xfrm>
                    <a:off x="5216696" y="6966863"/>
                    <a:ext cx="4985223" cy="1078849"/>
                    <a:chOff x="-2409538" y="1767463"/>
                    <a:chExt cx="4985223" cy="1078849"/>
                  </a:xfrm>
                </p:grpSpPr>
                <p:pic>
                  <p:nvPicPr>
                    <p:cNvPr id="24" name="Picture 23">
                      <a:extLst>
                        <a:ext uri="{FF2B5EF4-FFF2-40B4-BE49-F238E27FC236}">
                          <a16:creationId xmlns:a16="http://schemas.microsoft.com/office/drawing/2014/main" id="{F8A9D381-C7AC-E639-F47F-CD06FB5B710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10" t="13241" r="66860" b="78232"/>
                    <a:stretch/>
                  </p:blipFill>
                  <p:spPr>
                    <a:xfrm>
                      <a:off x="-2409538" y="1781735"/>
                      <a:ext cx="2016407" cy="1064577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" name="Picture 24">
                      <a:extLst>
                        <a:ext uri="{FF2B5EF4-FFF2-40B4-BE49-F238E27FC236}">
                          <a16:creationId xmlns:a16="http://schemas.microsoft.com/office/drawing/2014/main" id="{893DE209-3E6E-1950-50BC-AE6392E1110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8834" t="13241" r="3343" b="78232"/>
                    <a:stretch/>
                  </p:blipFill>
                  <p:spPr>
                    <a:xfrm>
                      <a:off x="-425197" y="1767463"/>
                      <a:ext cx="3000882" cy="1074392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2AA60719-D90D-4BA3-9CAC-E8D338D47527}"/>
                      </a:ext>
                    </a:extLst>
                  </p:cNvPr>
                  <p:cNvSpPr txBox="1"/>
                  <p:nvPr/>
                </p:nvSpPr>
                <p:spPr>
                  <a:xfrm>
                    <a:off x="5336689" y="7697606"/>
                    <a:ext cx="131570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0.55  99.3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C20C4254-1AA5-5B1E-CA42-6E7E33341E26}"/>
                      </a:ext>
                    </a:extLst>
                  </p:cNvPr>
                  <p:cNvSpPr txBox="1"/>
                  <p:nvPr/>
                </p:nvSpPr>
                <p:spPr>
                  <a:xfrm>
                    <a:off x="6311685" y="7687900"/>
                    <a:ext cx="125511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0.58  99.3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D769316A-F41E-1E67-403D-D7C4E6472173}"/>
                      </a:ext>
                    </a:extLst>
                  </p:cNvPr>
                  <p:cNvSpPr txBox="1"/>
                  <p:nvPr/>
                </p:nvSpPr>
                <p:spPr>
                  <a:xfrm>
                    <a:off x="7284439" y="7695800"/>
                    <a:ext cx="138184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0.82  99.1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13B95F24-7990-CDCA-CD57-F7E73C6F4532}"/>
                      </a:ext>
                    </a:extLst>
                  </p:cNvPr>
                  <p:cNvSpPr txBox="1"/>
                  <p:nvPr/>
                </p:nvSpPr>
                <p:spPr>
                  <a:xfrm>
                    <a:off x="8273267" y="7695799"/>
                    <a:ext cx="156953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1.34  98.6 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27AE2B1B-6493-0852-C14D-18251A0EC6CF}"/>
                      </a:ext>
                    </a:extLst>
                  </p:cNvPr>
                  <p:cNvSpPr txBox="1"/>
                  <p:nvPr/>
                </p:nvSpPr>
                <p:spPr>
                  <a:xfrm>
                    <a:off x="9278599" y="7710132"/>
                    <a:ext cx="129519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ＭＳ Ｐゴシック" charset="0"/>
                        <a:cs typeface="Arial" panose="020B0604020202020204" pitchFamily="34" charset="0"/>
                      </a:rPr>
                      <a:t>            1.43  98.4</a:t>
                    </a:r>
                    <a:endParaRPr lang="nl-NL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ＭＳ Ｐゴシック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8" name="Arrow: Right 7">
              <a:extLst>
                <a:ext uri="{FF2B5EF4-FFF2-40B4-BE49-F238E27FC236}">
                  <a16:creationId xmlns:a16="http://schemas.microsoft.com/office/drawing/2014/main" id="{6355FECD-AE0B-9DB2-8B1F-A56B08DF6EA4}"/>
                </a:ext>
              </a:extLst>
            </p:cNvPr>
            <p:cNvSpPr/>
            <p:nvPr/>
          </p:nvSpPr>
          <p:spPr>
            <a:xfrm>
              <a:off x="6807049" y="4439377"/>
              <a:ext cx="4854757" cy="224211"/>
            </a:xfrm>
            <a:prstGeom prst="right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l-NL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0572640-8392-3525-C518-9669835037CF}"/>
                </a:ext>
              </a:extLst>
            </p:cNvPr>
            <p:cNvSpPr txBox="1"/>
            <p:nvPr/>
          </p:nvSpPr>
          <p:spPr>
            <a:xfrm>
              <a:off x="8896821" y="4406083"/>
              <a:ext cx="70839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nl-NL" sz="1200" dirty="0">
                  <a:latin typeface="Verdana" panose="020B0604030504040204" pitchFamily="34" charset="0"/>
                  <a:ea typeface="Verdana" panose="020B0604030504040204" pitchFamily="34" charset="0"/>
                </a:rPr>
                <a:t>EGFP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9A1B09A6-4240-8974-3A6C-A37F41586DDD}"/>
              </a:ext>
            </a:extLst>
          </p:cNvPr>
          <p:cNvGrpSpPr/>
          <p:nvPr/>
        </p:nvGrpSpPr>
        <p:grpSpPr>
          <a:xfrm>
            <a:off x="1150918" y="935664"/>
            <a:ext cx="4366062" cy="2201013"/>
            <a:chOff x="66094" y="1220345"/>
            <a:chExt cx="4366062" cy="220101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3CE47C5-7E47-0DED-5981-2B572A3661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257"/>
            <a:stretch/>
          </p:blipFill>
          <p:spPr>
            <a:xfrm>
              <a:off x="178958" y="1220345"/>
              <a:ext cx="4253198" cy="2184922"/>
            </a:xfrm>
            <a:prstGeom prst="rect">
              <a:avLst/>
            </a:prstGeom>
          </p:spPr>
        </p:pic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3D2E18D4-920A-EF9F-79BC-B6BD8DAC2B00}"/>
                </a:ext>
              </a:extLst>
            </p:cNvPr>
            <p:cNvGrpSpPr/>
            <p:nvPr/>
          </p:nvGrpSpPr>
          <p:grpSpPr>
            <a:xfrm>
              <a:off x="66094" y="2839609"/>
              <a:ext cx="1032386" cy="581749"/>
              <a:chOff x="66094" y="2839609"/>
              <a:chExt cx="1032386" cy="581749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8C9AAF41-C1E5-DB5A-733C-BC61BDEFF712}"/>
                  </a:ext>
                </a:extLst>
              </p:cNvPr>
              <p:cNvSpPr/>
              <p:nvPr/>
            </p:nvSpPr>
            <p:spPr>
              <a:xfrm>
                <a:off x="157197" y="2839609"/>
                <a:ext cx="941283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GFP-</a:t>
                </a:r>
                <a:r>
                  <a:rPr lang="en-US" sz="900" b="1" dirty="0" err="1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Ontarg</a:t>
                </a:r>
                <a:endParaRPr lang="nl-NL" sz="700" b="1" dirty="0">
                  <a:solidFill>
                    <a:srgbClr val="FFFFFF"/>
                  </a:solidFill>
                  <a:latin typeface="Verdana" panose="020B0604030504040204" pitchFamily="34" charset="0"/>
                  <a:ea typeface="Verdana" panose="020B0604030504040204" pitchFamily="34" charset="0"/>
                </a:endParaRP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9C6376BD-21F1-14CC-C7A8-EF3F8CDE0F55}"/>
                  </a:ext>
                </a:extLst>
              </p:cNvPr>
              <p:cNvSpPr/>
              <p:nvPr/>
            </p:nvSpPr>
            <p:spPr>
              <a:xfrm>
                <a:off x="73841" y="3018871"/>
                <a:ext cx="1024639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     Offtarg-1</a:t>
                </a:r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A4543B20-4430-45FE-109F-978BD1DC7045}"/>
                  </a:ext>
                </a:extLst>
              </p:cNvPr>
              <p:cNvSpPr/>
              <p:nvPr/>
            </p:nvSpPr>
            <p:spPr>
              <a:xfrm>
                <a:off x="66094" y="3190526"/>
                <a:ext cx="1024639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Verdana" panose="020B060403050404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     Offtarg-2</a:t>
                </a:r>
              </a:p>
            </p:txBody>
          </p:sp>
        </p:grpSp>
      </p:grpSp>
      <p:pic>
        <p:nvPicPr>
          <p:cNvPr id="45" name="Picture 44">
            <a:extLst>
              <a:ext uri="{FF2B5EF4-FFF2-40B4-BE49-F238E27FC236}">
                <a16:creationId xmlns:a16="http://schemas.microsoft.com/office/drawing/2014/main" id="{81E2D01C-E031-924F-DDC5-07AD89CE166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558" y="7330417"/>
            <a:ext cx="4048875" cy="271094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7914F773-3D30-8A54-FDE8-58981574284B}"/>
              </a:ext>
            </a:extLst>
          </p:cNvPr>
          <p:cNvSpPr txBox="1"/>
          <p:nvPr/>
        </p:nvSpPr>
        <p:spPr>
          <a:xfrm>
            <a:off x="5980302" y="3858650"/>
            <a:ext cx="4154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nl-NL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8D90798-6CE5-F350-310E-D1D915DAAA5C}"/>
              </a:ext>
            </a:extLst>
          </p:cNvPr>
          <p:cNvSpPr txBox="1"/>
          <p:nvPr/>
        </p:nvSpPr>
        <p:spPr>
          <a:xfrm>
            <a:off x="0" y="7392225"/>
            <a:ext cx="415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819809-2D45-8610-4671-39F0944FEAE1}"/>
              </a:ext>
            </a:extLst>
          </p:cNvPr>
          <p:cNvSpPr txBox="1"/>
          <p:nvPr/>
        </p:nvSpPr>
        <p:spPr>
          <a:xfrm>
            <a:off x="24035" y="204470"/>
            <a:ext cx="39442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nl-NL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C49576E-91EF-2C35-77CE-615C610BBD2D}"/>
              </a:ext>
            </a:extLst>
          </p:cNvPr>
          <p:cNvSpPr txBox="1"/>
          <p:nvPr/>
        </p:nvSpPr>
        <p:spPr>
          <a:xfrm>
            <a:off x="27272" y="670388"/>
            <a:ext cx="415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6665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AA42B86-4E95-546A-E803-CB89D7335548}"/>
              </a:ext>
            </a:extLst>
          </p:cNvPr>
          <p:cNvSpPr txBox="1"/>
          <p:nvPr/>
        </p:nvSpPr>
        <p:spPr>
          <a:xfrm>
            <a:off x="150124" y="312055"/>
            <a:ext cx="7233315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CRISPR/Cas9-mediated on- or off-target effects. </a:t>
            </a:r>
          </a:p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The on-target and off-target EGFP gRNAs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K562-H2A-GFP cells were transfected with either the SpCas9-on-target or off-target- #1, #2 gRNA complex against GFP. Loss of GFP was monitored as the readout of CRISPR/Cas9 editing efficiency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Quantification of the editing efficiency from B. 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431524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1</TotalTime>
  <Words>406</Words>
  <Application>Microsoft Office PowerPoint</Application>
  <PresentationFormat>Custom</PresentationFormat>
  <Paragraphs>4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Verdana</vt:lpstr>
      <vt:lpstr>Simple Light</vt:lpstr>
      <vt:lpstr>Shengnan Sun1,3, Renhong Sun2,3, Minkang Tan1, Maarten Kip1, Xiaobao Yang2*, Baoxu Pang1* 1Department of Cell and Chemical Biology, Leiden University Medical Center, Leiden, The Netherlands 2Gluetacs Therapeutics (Shanghai) Co, Ltd, Pudong District, Shanghai, China 3These authors contributed equally *Correspondence: b.pang@lumc.nl (B.P.), yang.xiaobao@gluetacs.com (X.Y.)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Sun, S. (CCB)</cp:lastModifiedBy>
  <cp:revision>51</cp:revision>
  <dcterms:modified xsi:type="dcterms:W3CDTF">2025-07-14T09:10:48Z</dcterms:modified>
</cp:coreProperties>
</file>